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81" d="100"/>
          <a:sy n="81" d="100"/>
        </p:scale>
        <p:origin x="-300" y="-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B30FD47-AFC0-4021-A808-E4E01908A2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FE122017-E93E-4526-BD38-B3EEF16ADC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AF46D97-D042-431D-8A7B-5F3B3EA2F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72FCF1D-BA8C-4A3D-9E0E-9B4D32490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1EFAB5C-D418-4E1E-A1BC-15D64799A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40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E58A6B7-5209-432E-AE1D-F913972A72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95F782E2-AAFE-4BC3-9BD2-354B5D66DB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8D0D2CC-B455-4B17-9C87-532AB18E9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7B48477-4D78-4A41-8C18-764CFDB9AC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B307293-7882-4AEC-A665-D1A9888AB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157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C40C1983-538D-4FB0-8B18-108097B26E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6F9BD8BF-5C5D-4EA4-B5CC-6D7BB68307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76B07FB-88CA-4298-A905-DF38B4219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0566C7A-2E70-4A27-8C70-9FD62F7D3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559922F-DF82-4899-B2FF-2FAC99823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486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07EC761-6182-4DA1-B8CD-F1A6F86B7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39041C7-E8F8-4683-841A-4C107C46B9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98C2C96-F356-454A-976B-5B1E0B7DF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DEF46C7-AB81-4565-8223-EFA350BB3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2ACB52F-11F0-44BC-886A-0260AD03D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425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E3F74EA-DAC7-41E6-9AE8-AEE49C269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B3BF27D-88FC-40AA-820A-4B9BD16909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02904A4-D246-4764-8865-8A1A3C189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85BFE3D-628C-4165-92F5-54571650F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8384F4C-BEE5-466B-B9D1-B35C35787B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643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E4FA6CE-7C1B-45EB-A8F5-EAED7C2149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ABE9584-22FE-4B53-90F3-4CFF898680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ECB3C76-B576-418A-95FF-48A935DC84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5239273-C3D4-41A0-A672-4883F4B73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4F97D67-3BFB-4B93-A7AE-AA8C50E4B6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4456C9F-19C9-4446-8282-F18CD0D9C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929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F50AE61-D99F-4912-97FB-E57D107ED3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579251F-5D75-4414-8E11-846DAA2ECD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5A4B476-FCDA-4B5C-A148-16DD03D28E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9B1593DA-9788-4DD8-B49A-52304398EE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C4FFA7E0-F655-4AF0-98E6-CFBD8811DF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8991A450-04E7-4066-B5B9-925539E58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27DF1CD3-9F77-4D68-8BEB-470FFE9CD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80C76B12-5465-498C-927C-06250597B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496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6CA93A8-8499-45EC-9BF5-AEEE379E0E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6CD626A8-2686-4232-9AA3-AA814D346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6BDFA245-415D-454F-9FB4-F1ED0A449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B4EE32CD-8A01-4793-8ED7-05EFCDE5B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005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DCF7DA0D-1E4C-4641-BD45-C9286B0EE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E83E4CBC-A36F-40D1-AE00-0B853B07AD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8066B0E6-EFE5-4250-9DEE-6AA05DD55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951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8D134B4-B8D2-458C-BF37-7CF799E9A9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B98A4C7-6CC1-4614-BD5C-D018643FC8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F314069-3287-4ACB-B077-342536B917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48CB33E-F246-4C6F-ADF6-382D49403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F6F1B798-F0EA-4A2E-8431-EC3EDBC6A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B761BA9-F245-4E89-9E24-DCDB1487A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631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3A334E9-9149-47F0-B02F-CC2864F3BC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8CD02B36-2FAE-4003-A545-105BD259CA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05F0F54-594C-4995-9743-857B993ADD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66B08EC-0E6D-44B9-BB7A-0BA4036F6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F0898E4-FEAB-4C1B-93F1-53F6A3F7B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5F5BEF0-6311-464D-8B66-0D3F4FBCA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299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5B1E2D8F-BF52-45B0-A3D4-1E5CDDFEB1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B5D082C-5621-470A-BDFA-22101F401D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A809B26-366A-49CF-B2E7-56A575A85F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9F9AEDB-064D-4334-8502-340F213336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5DAF390-77A8-42DA-A361-F03A8C7FCF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968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7D0824EA-1CDD-430B-AD96-88F5293CF6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116822"/>
              </p:ext>
            </p:extLst>
          </p:nvPr>
        </p:nvGraphicFramePr>
        <p:xfrm>
          <a:off x="1797717" y="1343066"/>
          <a:ext cx="8115301" cy="2428875"/>
        </p:xfrm>
        <a:graphic>
          <a:graphicData uri="http://schemas.openxmlformats.org/drawingml/2006/table">
            <a:tbl>
              <a:tblPr/>
              <a:tblGrid>
                <a:gridCol w="1169288">
                  <a:extLst>
                    <a:ext uri="{9D8B030D-6E8A-4147-A177-3AD203B41FA5}">
                      <a16:colId xmlns:a16="http://schemas.microsoft.com/office/drawing/2014/main" xmlns="" val="2728487786"/>
                    </a:ext>
                  </a:extLst>
                </a:gridCol>
                <a:gridCol w="1055211">
                  <a:extLst>
                    <a:ext uri="{9D8B030D-6E8A-4147-A177-3AD203B41FA5}">
                      <a16:colId xmlns:a16="http://schemas.microsoft.com/office/drawing/2014/main" xmlns="" val="1690867323"/>
                    </a:ext>
                  </a:extLst>
                </a:gridCol>
                <a:gridCol w="1014016">
                  <a:extLst>
                    <a:ext uri="{9D8B030D-6E8A-4147-A177-3AD203B41FA5}">
                      <a16:colId xmlns:a16="http://schemas.microsoft.com/office/drawing/2014/main" xmlns="" val="3159662292"/>
                    </a:ext>
                  </a:extLst>
                </a:gridCol>
                <a:gridCol w="1368922">
                  <a:extLst>
                    <a:ext uri="{9D8B030D-6E8A-4147-A177-3AD203B41FA5}">
                      <a16:colId xmlns:a16="http://schemas.microsoft.com/office/drawing/2014/main" xmlns="" val="1142790004"/>
                    </a:ext>
                  </a:extLst>
                </a:gridCol>
                <a:gridCol w="1169288">
                  <a:extLst>
                    <a:ext uri="{9D8B030D-6E8A-4147-A177-3AD203B41FA5}">
                      <a16:colId xmlns:a16="http://schemas.microsoft.com/office/drawing/2014/main" xmlns="" val="1621001982"/>
                    </a:ext>
                  </a:extLst>
                </a:gridCol>
                <a:gridCol w="1169288">
                  <a:extLst>
                    <a:ext uri="{9D8B030D-6E8A-4147-A177-3AD203B41FA5}">
                      <a16:colId xmlns:a16="http://schemas.microsoft.com/office/drawing/2014/main" xmlns="" val="2755308991"/>
                    </a:ext>
                  </a:extLst>
                </a:gridCol>
                <a:gridCol w="1169288">
                  <a:extLst>
                    <a:ext uri="{9D8B030D-6E8A-4147-A177-3AD203B41FA5}">
                      <a16:colId xmlns:a16="http://schemas.microsoft.com/office/drawing/2014/main" xmlns="" val="4010064561"/>
                    </a:ext>
                  </a:extLst>
                </a:gridCol>
              </a:tblGrid>
              <a:tr h="571500">
                <a:tc gridSpan="7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1- MS/MS parameters for each TCA cycle intermediate analyzed on a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trap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S.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184414505"/>
                  </a:ext>
                </a:extLst>
              </a:tr>
              <a:tr h="3333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ound             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Precursor       (m/z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Product Ion         (m/z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clustering Potenti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it Potenti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lision Energ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Exit Potenti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77781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ccinic Ac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967649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tric Ac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010367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ic Ac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6482739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ic Acid-d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27008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yruvic Ac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1669167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tic Ac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440573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maric Ac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1536745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l-G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togluteric Ac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041414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92314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33</Words>
  <Application>Microsoft Office PowerPoint</Application>
  <PresentationFormat>Custom</PresentationFormat>
  <Paragraphs>6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yce, Gregory (CDC/NIOSH/HELD/ACIB)</dc:creator>
  <cp:lastModifiedBy>Baranieswaran</cp:lastModifiedBy>
  <cp:revision>2</cp:revision>
  <dcterms:created xsi:type="dcterms:W3CDTF">2020-04-30T12:01:48Z</dcterms:created>
  <dcterms:modified xsi:type="dcterms:W3CDTF">2020-06-24T05:13:34Z</dcterms:modified>
</cp:coreProperties>
</file>